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167EC-1FB8-462B-9513-A7C808B8FE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22F38-679E-43D8-8A86-07E0636D43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7EC30-08CA-456F-A7C2-D947A57F44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4A784-C6B4-480B-A333-4541F2A15F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3C1D8-5112-4D95-AA63-1A8D28E63E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0893A-778E-44A6-8E85-A80F14BC89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26613-1F78-47BC-A625-ACBA7E20CB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301AF-178B-42F5-8791-BA142584EE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9BB03-A588-4596-B567-5060C03874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A3A4C-6DAA-418C-9BE4-A44DEB5C0A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901C2-6ACC-477D-AF7E-5464E92EC2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377DE-E696-4003-8761-DA221D5EFD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53B9A4-F1AB-4C72-AF9F-6F9309C3B831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86040" y="24462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12966" r="2362" b="13333"/>
          <a:stretch/>
        </p:blipFill>
        <p:spPr>
          <a:xfrm>
            <a:off x="38160" y="243000"/>
            <a:ext cx="9029520" cy="50911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28600" y="5562720"/>
            <a:ext cx="8763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lignment of the six LGR protein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 amoebophil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Carried out with MEGA 3.1 using default parameters, this alignment reveals how these proteins are closely related and detects a 28-residue period at the carboxy-terminal end of the sequence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19:52Z</dcterms:created>
  <dc:creator>Gilbert Greub</dc:creator>
  <dc:description/>
  <dc:language>en-US</dc:language>
  <cp:lastModifiedBy>CA Roten</cp:lastModifiedBy>
  <dcterms:modified xsi:type="dcterms:W3CDTF">2007-11-14T08:01:08Z</dcterms:modified>
  <cp:revision>5</cp:revision>
  <dc:subject/>
  <dc:title>Présentation PowerPoint</dc:title>
</cp:coreProperties>
</file>